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>
      <p:cViewPr varScale="1">
        <p:scale>
          <a:sx n="84" d="100"/>
          <a:sy n="84" d="100"/>
        </p:scale>
        <p:origin x="283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05607-146C-4BEA-96AD-BBB419D39ADB}" type="datetimeFigureOut">
              <a:rPr lang="de-CH" smtClean="0"/>
              <a:t>20.08.20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C9003-BB6D-428E-8AE1-EDD312CD5C2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169321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05607-146C-4BEA-96AD-BBB419D39ADB}" type="datetimeFigureOut">
              <a:rPr lang="de-CH" smtClean="0"/>
              <a:t>20.08.20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C9003-BB6D-428E-8AE1-EDD312CD5C2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542077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05607-146C-4BEA-96AD-BBB419D39ADB}" type="datetimeFigureOut">
              <a:rPr lang="de-CH" smtClean="0"/>
              <a:t>20.08.20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C9003-BB6D-428E-8AE1-EDD312CD5C2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6278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05607-146C-4BEA-96AD-BBB419D39ADB}" type="datetimeFigureOut">
              <a:rPr lang="de-CH" smtClean="0"/>
              <a:t>20.08.20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C9003-BB6D-428E-8AE1-EDD312CD5C2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1897145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05607-146C-4BEA-96AD-BBB419D39ADB}" type="datetimeFigureOut">
              <a:rPr lang="de-CH" smtClean="0"/>
              <a:t>20.08.20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C9003-BB6D-428E-8AE1-EDD312CD5C2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558736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05607-146C-4BEA-96AD-BBB419D39ADB}" type="datetimeFigureOut">
              <a:rPr lang="de-CH" smtClean="0"/>
              <a:t>20.08.2025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C9003-BB6D-428E-8AE1-EDD312CD5C2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0859774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05607-146C-4BEA-96AD-BBB419D39ADB}" type="datetimeFigureOut">
              <a:rPr lang="de-CH" smtClean="0"/>
              <a:t>20.08.2025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C9003-BB6D-428E-8AE1-EDD312CD5C2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950527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05607-146C-4BEA-96AD-BBB419D39ADB}" type="datetimeFigureOut">
              <a:rPr lang="de-CH" smtClean="0"/>
              <a:t>20.08.2025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C9003-BB6D-428E-8AE1-EDD312CD5C2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723757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05607-146C-4BEA-96AD-BBB419D39ADB}" type="datetimeFigureOut">
              <a:rPr lang="de-CH" smtClean="0"/>
              <a:t>20.08.2025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C9003-BB6D-428E-8AE1-EDD312CD5C2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6390488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05607-146C-4BEA-96AD-BBB419D39ADB}" type="datetimeFigureOut">
              <a:rPr lang="de-CH" smtClean="0"/>
              <a:t>20.08.2025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C9003-BB6D-428E-8AE1-EDD312CD5C2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680123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05607-146C-4BEA-96AD-BBB419D39ADB}" type="datetimeFigureOut">
              <a:rPr lang="de-CH" smtClean="0"/>
              <a:t>20.08.2025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C9003-BB6D-428E-8AE1-EDD312CD5C2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37730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105607-146C-4BEA-96AD-BBB419D39ADB}" type="datetimeFigureOut">
              <a:rPr lang="de-CH" smtClean="0"/>
              <a:t>20.08.20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E2C9003-BB6D-428E-8AE1-EDD312CD5C2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999214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DE6BD38F-3489-78B1-A5D0-178C22D363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0190" y="0"/>
            <a:ext cx="5319347" cy="4181254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35773CE2-4BA7-6DCC-A98D-C06CCBE4C642}"/>
              </a:ext>
            </a:extLst>
          </p:cNvPr>
          <p:cNvSpPr txBox="1"/>
          <p:nvPr/>
        </p:nvSpPr>
        <p:spPr>
          <a:xfrm>
            <a:off x="11430" y="2834640"/>
            <a:ext cx="265175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umber of nodes:	28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umber of edges:	75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verage node degree:	5.36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vg. local clustering coefficient: 0.562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xpected number of edges:	14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PI enrichment p-value:	&lt; 1.0e-16</a:t>
            </a:r>
          </a:p>
        </p:txBody>
      </p:sp>
      <p:pic>
        <p:nvPicPr>
          <p:cNvPr id="8" name="Grafik 7">
            <a:extLst>
              <a:ext uri="{FF2B5EF4-FFF2-40B4-BE49-F238E27FC236}">
                <a16:creationId xmlns:a16="http://schemas.microsoft.com/office/drawing/2014/main" id="{AA0B86D8-C7BC-C8D7-D3EC-8B332CF1791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138416"/>
            <a:ext cx="6858000" cy="3838968"/>
          </a:xfrm>
          <a:prstGeom prst="rect">
            <a:avLst/>
          </a:prstGeom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id="{62610463-059C-8D42-C7C4-443F6DE5C16A}"/>
              </a:ext>
            </a:extLst>
          </p:cNvPr>
          <p:cNvSpPr txBox="1"/>
          <p:nvPr/>
        </p:nvSpPr>
        <p:spPr>
          <a:xfrm>
            <a:off x="11430" y="7966710"/>
            <a:ext cx="682810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Interaction network and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biological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process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enrichment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specific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host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DE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proteins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higher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levels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in  HFFs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infected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TGME49_319730_KO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strain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compared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HFFs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infected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i="1" dirty="0">
                <a:latin typeface="Arial" panose="020B0604020202020204" pitchFamily="34" charset="0"/>
                <a:cs typeface="Arial" panose="020B0604020202020204" pitchFamily="34" charset="0"/>
              </a:rPr>
              <a:t>T. gondii 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Sp1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Wildtype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086147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0</Words>
  <Application>Microsoft Office PowerPoint</Application>
  <PresentationFormat>Bildschirmpräsentation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</vt:lpstr>
      <vt:lpstr>PowerPoint-Präsentation</vt:lpstr>
    </vt:vector>
  </TitlesOfParts>
  <Company>Vetsuisse Ber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üller, Joachim (VETSUISSE)</dc:creator>
  <cp:lastModifiedBy>Müller, Joachim (VETSUISSE)</cp:lastModifiedBy>
  <cp:revision>1</cp:revision>
  <dcterms:created xsi:type="dcterms:W3CDTF">2025-08-20T06:05:41Z</dcterms:created>
  <dcterms:modified xsi:type="dcterms:W3CDTF">2025-08-20T06:15:40Z</dcterms:modified>
</cp:coreProperties>
</file>